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1" r:id="rId2"/>
    <p:sldId id="28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DA7424-F72B-1EB5-697F-CA9333E57F0A}" name="PhilR" initials="PJR" userId="PhilR" providerId="None"/>
  <p188:author id="{3B063878-6895-4B8D-823B-C7D9104357F1}" name="Roger Reddel" initials="RR" userId="S::rreddel@cmri.org.au::750bfe6e-02cc-4cce-a1ed-bde13e6cbbb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13" autoAdjust="0"/>
    <p:restoredTop sz="95748" autoAdjust="0"/>
  </p:normalViewPr>
  <p:slideViewPr>
    <p:cSldViewPr snapToGrid="0">
      <p:cViewPr varScale="1">
        <p:scale>
          <a:sx n="69" d="100"/>
          <a:sy n="69" d="100"/>
        </p:scale>
        <p:origin x="23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BFE566-B291-6C40-A8EB-8EA7FEA7A444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0A3A11-C076-CF4F-B186-F8DBC4F2A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979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9312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0091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6602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3282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4586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539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112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6183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182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81319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9719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5162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3D55AE4-5531-1346-5F80-12479EBF4C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5077" y="4474875"/>
            <a:ext cx="5394837" cy="525563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CF2F7C1-C315-A022-9392-0F66443F782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8380" y="540909"/>
            <a:ext cx="3641240" cy="376463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802D3C5-01DE-452D-B3F1-3F63F7383314}"/>
              </a:ext>
            </a:extLst>
          </p:cNvPr>
          <p:cNvSpPr txBox="1"/>
          <p:nvPr/>
        </p:nvSpPr>
        <p:spPr>
          <a:xfrm>
            <a:off x="262702" y="26393"/>
            <a:ext cx="3996814" cy="3262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2744DD4-DB9B-4B2B-AFA2-F91E31D8B5EC}"/>
              </a:ext>
            </a:extLst>
          </p:cNvPr>
          <p:cNvSpPr txBox="1"/>
          <p:nvPr/>
        </p:nvSpPr>
        <p:spPr>
          <a:xfrm>
            <a:off x="380188" y="490606"/>
            <a:ext cx="529955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5161221-CC6F-45C5-BCAF-CCFC7497EB4C}"/>
              </a:ext>
            </a:extLst>
          </p:cNvPr>
          <p:cNvSpPr txBox="1"/>
          <p:nvPr/>
        </p:nvSpPr>
        <p:spPr>
          <a:xfrm>
            <a:off x="380187" y="4474875"/>
            <a:ext cx="529955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2FC9927-A54A-44E5-B3A5-703CF501D46D}"/>
              </a:ext>
            </a:extLst>
          </p:cNvPr>
          <p:cNvSpPr txBox="1"/>
          <p:nvPr/>
        </p:nvSpPr>
        <p:spPr>
          <a:xfrm>
            <a:off x="774227" y="540908"/>
            <a:ext cx="1324256" cy="11126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85000"/>
              </a:lnSpc>
            </a:pP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2,018 Down-regulated peptides (396 proteins) in tumor relative to normal</a:t>
            </a:r>
            <a:endParaRPr lang="en-AU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BB4DAD-5840-4FA9-889E-54EFA3183BD3}"/>
              </a:ext>
            </a:extLst>
          </p:cNvPr>
          <p:cNvSpPr txBox="1"/>
          <p:nvPr/>
        </p:nvSpPr>
        <p:spPr>
          <a:xfrm>
            <a:off x="5174958" y="540908"/>
            <a:ext cx="1238872" cy="12826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85000"/>
              </a:lnSpc>
            </a:pP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2,816 Up-regulated peptides (1,218 proteins) in tumor relative to normal</a:t>
            </a:r>
            <a:endParaRPr lang="en-AU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68748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7ABBD28-F97A-36D4-5697-8DA7AEC05367}"/>
              </a:ext>
            </a:extLst>
          </p:cNvPr>
          <p:cNvSpPr txBox="1"/>
          <p:nvPr/>
        </p:nvSpPr>
        <p:spPr>
          <a:xfrm>
            <a:off x="304799" y="484909"/>
            <a:ext cx="6428509" cy="35523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AU" sz="1200" b="0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Supplementary Figure S1</a:t>
            </a: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: Differential abundance 1,614 unique protein groups from 4,834 DAPeps discriminates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tumor</a:t>
            </a: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 and NAT patient samples</a:t>
            </a:r>
          </a:p>
          <a:p>
            <a:pPr>
              <a:lnSpc>
                <a:spcPct val="150000"/>
              </a:lnSpc>
            </a:pPr>
            <a:r>
              <a:rPr lang="en-AU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Volcano plot shows the distribution of 1,614 proteins significantly up- or down-regulated in recurrence vs non-recurrence in HPV-associated OPSCC patient samples.  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re were 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,018 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eptides (from 396 unique protein groups) down-regulated in </a:t>
            </a:r>
            <a:r>
              <a:rPr lang="en-AU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s. NAT and 2,816 peptides (from 1,218 unique protein groups) up-regulated in </a:t>
            </a:r>
            <a:r>
              <a:rPr lang="en-AU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t an adjusted </a:t>
            </a:r>
            <a:r>
              <a:rPr lang="en-AU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 of 0.01 (1% FDR).  Axes show fold-change (FC) &gt; 1.5 adjusted </a:t>
            </a:r>
            <a:r>
              <a:rPr lang="en-AU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 &lt; 0.01.  Significant peptides are indicated in red (increased in R) or blue </a:t>
            </a:r>
            <a:r>
              <a:rPr lang="en-AU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lor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decreased in R).  Most peptides showed low FC after differential expression analysis (coloured </a:t>
            </a:r>
            <a:r>
              <a:rPr lang="en-AU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ray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endParaRPr lang="en-AU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AU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Heatmap representation of the z-scores obtained after </a:t>
            </a:r>
            <a:r>
              <a:rPr lang="en-AU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unsupervized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hierarchical clustering of the DAPeps from panel a).  Expression data are converted to z-scores.  Samples are shown on the x-axis whereas peptides are clustered on the y-axis against </a:t>
            </a:r>
            <a:r>
              <a:rPr lang="en-AU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s. NAT samples or some 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inicopathological variables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697265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95</TotalTime>
  <Words>210</Words>
  <Application>Microsoft Office PowerPoint</Application>
  <PresentationFormat>A4 Paper (210x297 mm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R</dc:creator>
  <cp:lastModifiedBy>PhilR</cp:lastModifiedBy>
  <cp:revision>325</cp:revision>
  <dcterms:created xsi:type="dcterms:W3CDTF">2022-08-07T22:18:57Z</dcterms:created>
  <dcterms:modified xsi:type="dcterms:W3CDTF">2025-02-23T23:00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XPowerLiteLastOptimized">
    <vt:lpwstr>4123633</vt:lpwstr>
  </property>
  <property fmtid="{D5CDD505-2E9C-101B-9397-08002B2CF9AE}" pid="3" name="NXPowerLiteSettings">
    <vt:lpwstr>E9000A40064001</vt:lpwstr>
  </property>
  <property fmtid="{D5CDD505-2E9C-101B-9397-08002B2CF9AE}" pid="4" name="NXPowerLiteVersion">
    <vt:lpwstr>D9.1.2</vt:lpwstr>
  </property>
</Properties>
</file>